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5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E0322-9538-488E-B318-436190DC2C4A}" type="datetimeFigureOut">
              <a:rPr lang="en-GB" smtClean="0"/>
              <a:pPr/>
              <a:t>25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D3DE-C5A4-42FC-B83B-D3FDFB5FBD1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E0322-9538-488E-B318-436190DC2C4A}" type="datetimeFigureOut">
              <a:rPr lang="en-GB" smtClean="0"/>
              <a:pPr/>
              <a:t>25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D3DE-C5A4-42FC-B83B-D3FDFB5FBD1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E0322-9538-488E-B318-436190DC2C4A}" type="datetimeFigureOut">
              <a:rPr lang="en-GB" smtClean="0"/>
              <a:pPr/>
              <a:t>25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D3DE-C5A4-42FC-B83B-D3FDFB5FBD1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E0322-9538-488E-B318-436190DC2C4A}" type="datetimeFigureOut">
              <a:rPr lang="en-GB" smtClean="0"/>
              <a:pPr/>
              <a:t>25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D3DE-C5A4-42FC-B83B-D3FDFB5FBD1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E0322-9538-488E-B318-436190DC2C4A}" type="datetimeFigureOut">
              <a:rPr lang="en-GB" smtClean="0"/>
              <a:pPr/>
              <a:t>25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D3DE-C5A4-42FC-B83B-D3FDFB5FBD1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E0322-9538-488E-B318-436190DC2C4A}" type="datetimeFigureOut">
              <a:rPr lang="en-GB" smtClean="0"/>
              <a:pPr/>
              <a:t>25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D3DE-C5A4-42FC-B83B-D3FDFB5FBD1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E0322-9538-488E-B318-436190DC2C4A}" type="datetimeFigureOut">
              <a:rPr lang="en-GB" smtClean="0"/>
              <a:pPr/>
              <a:t>25/06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D3DE-C5A4-42FC-B83B-D3FDFB5FBD1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E0322-9538-488E-B318-436190DC2C4A}" type="datetimeFigureOut">
              <a:rPr lang="en-GB" smtClean="0"/>
              <a:pPr/>
              <a:t>25/06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D3DE-C5A4-42FC-B83B-D3FDFB5FBD1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E0322-9538-488E-B318-436190DC2C4A}" type="datetimeFigureOut">
              <a:rPr lang="en-GB" smtClean="0"/>
              <a:pPr/>
              <a:t>25/06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D3DE-C5A4-42FC-B83B-D3FDFB5FBD1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E0322-9538-488E-B318-436190DC2C4A}" type="datetimeFigureOut">
              <a:rPr lang="en-GB" smtClean="0"/>
              <a:pPr/>
              <a:t>25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D3DE-C5A4-42FC-B83B-D3FDFB5FBD1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E0322-9538-488E-B318-436190DC2C4A}" type="datetimeFigureOut">
              <a:rPr lang="en-GB" smtClean="0"/>
              <a:pPr/>
              <a:t>25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D3DE-C5A4-42FC-B83B-D3FDFB5FBD1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9E0322-9538-488E-B318-436190DC2C4A}" type="datetimeFigureOut">
              <a:rPr lang="en-GB" smtClean="0"/>
              <a:pPr/>
              <a:t>25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90D3DE-C5A4-42FC-B83B-D3FDFB5FBD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323528" y="260648"/>
            <a:ext cx="52565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dditional file 4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395536" y="5889466"/>
            <a:ext cx="784887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Additional file 4</a:t>
            </a:r>
            <a:r>
              <a:rPr lang="en-GB" sz="1000" b="1" dirty="0" smtClean="0"/>
              <a:t>. </a:t>
            </a:r>
            <a:r>
              <a:rPr lang="en-GB" sz="1000" dirty="0" smtClean="0"/>
              <a:t> </a:t>
            </a:r>
            <a:r>
              <a:rPr lang="en-GB" sz="1000" dirty="0"/>
              <a:t>Principal component analysis (PCA) plots of SRM-MS data obtained </a:t>
            </a:r>
            <a:r>
              <a:rPr lang="en-GB" sz="1000" dirty="0" smtClean="0"/>
              <a:t>from the cerebellum. In </a:t>
            </a:r>
            <a:r>
              <a:rPr lang="en-GB" sz="1000" dirty="0"/>
              <a:t>the PCA plots, every run is represented as a data point and all triplicates of the same run have the same colour. Samples of both controls and patients are visualised</a:t>
            </a:r>
            <a:r>
              <a:rPr lang="en-GB" sz="1000" dirty="0" smtClean="0"/>
              <a:t>. After removal of one outlier, the PCA plot showed no segregation of samples, indicating that a batch effect was not present. </a:t>
            </a:r>
            <a:r>
              <a:rPr lang="en-GB" sz="1000" dirty="0"/>
              <a:t>The </a:t>
            </a:r>
            <a:r>
              <a:rPr lang="en-GB" sz="1000" dirty="0" smtClean="0"/>
              <a:t>accompanying </a:t>
            </a:r>
            <a:r>
              <a:rPr lang="en-GB" sz="1000" dirty="0"/>
              <a:t>text with the data points is not similar to the sample code depicted in table </a:t>
            </a:r>
            <a:r>
              <a:rPr lang="en-GB" sz="1000" dirty="0" smtClean="0"/>
              <a:t>1.</a:t>
            </a:r>
            <a:endParaRPr lang="en-GB" sz="1000" dirty="0" smtClean="0"/>
          </a:p>
        </p:txBody>
      </p:sp>
      <p:pic>
        <p:nvPicPr>
          <p:cNvPr id="12" name="Picture 11"/>
          <p:cNvPicPr/>
          <p:nvPr/>
        </p:nvPicPr>
        <p:blipFill>
          <a:blip r:embed="rId2" cstate="print"/>
          <a:srcRect l="17616" t="16413" r="953" b="13690"/>
          <a:stretch>
            <a:fillRect/>
          </a:stretch>
        </p:blipFill>
        <p:spPr bwMode="auto">
          <a:xfrm>
            <a:off x="467544" y="692696"/>
            <a:ext cx="7131757" cy="48965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99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cb86</dc:creator>
  <cp:lastModifiedBy>acb86</cp:lastModifiedBy>
  <cp:revision>3</cp:revision>
  <dcterms:created xsi:type="dcterms:W3CDTF">2014-04-02T12:58:29Z</dcterms:created>
  <dcterms:modified xsi:type="dcterms:W3CDTF">2014-06-25T14:16:23Z</dcterms:modified>
</cp:coreProperties>
</file>